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itka Malčíková" initials="JM" lastIdx="3" clrIdx="0">
    <p:extLst>
      <p:ext uri="{19B8F6BF-5375-455C-9EA6-DF929625EA0E}">
        <p15:presenceInfo xmlns:p15="http://schemas.microsoft.com/office/powerpoint/2012/main" userId="Jitka Malčíková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5A2EB75-8ABB-4834-848C-F99142CEA8F9}" v="5" dt="2022-09-18T17:58:19.94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1" d="100"/>
          <a:sy n="61" d="100"/>
        </p:scale>
        <p:origin x="6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itka Malčíková" userId="ea0e4c04-9731-427c-835c-08f588855602" providerId="ADAL" clId="{419BE824-69FC-48DD-889E-8176C568E3A0}"/>
    <pc:docChg chg="modSld">
      <pc:chgData name="Jitka Malčíková" userId="ea0e4c04-9731-427c-835c-08f588855602" providerId="ADAL" clId="{419BE824-69FC-48DD-889E-8176C568E3A0}" dt="2022-09-18T19:50:39.508" v="4"/>
      <pc:docMkLst>
        <pc:docMk/>
      </pc:docMkLst>
      <pc:sldChg chg="addCm modCm">
        <pc:chgData name="Jitka Malčíková" userId="ea0e4c04-9731-427c-835c-08f588855602" providerId="ADAL" clId="{419BE824-69FC-48DD-889E-8176C568E3A0}" dt="2022-09-18T19:50:39.508" v="4"/>
        <pc:sldMkLst>
          <pc:docMk/>
          <pc:sldMk cId="3731668930" sldId="256"/>
        </pc:sldMkLst>
      </pc:sldChg>
    </pc:docChg>
  </pc:docChgLst>
  <pc:docChgLst>
    <pc:chgData name="Pešová Michaela" userId="S::1770@fnbrno.cz::ed81fb3f-6043-4d42-bdb6-53f11b6befb6" providerId="AD" clId="Web-{45A2EB75-8ABB-4834-848C-F99142CEA8F9}"/>
    <pc:docChg chg="modSld">
      <pc:chgData name="Pešová Michaela" userId="S::1770@fnbrno.cz::ed81fb3f-6043-4d42-bdb6-53f11b6befb6" providerId="AD" clId="Web-{45A2EB75-8ABB-4834-848C-F99142CEA8F9}" dt="2022-09-18T17:58:19.676" v="1" actId="20577"/>
      <pc:docMkLst>
        <pc:docMk/>
      </pc:docMkLst>
      <pc:sldChg chg="modSp">
        <pc:chgData name="Pešová Michaela" userId="S::1770@fnbrno.cz::ed81fb3f-6043-4d42-bdb6-53f11b6befb6" providerId="AD" clId="Web-{45A2EB75-8ABB-4834-848C-F99142CEA8F9}" dt="2022-09-18T17:58:19.676" v="1" actId="20577"/>
        <pc:sldMkLst>
          <pc:docMk/>
          <pc:sldMk cId="3731668930" sldId="256"/>
        </pc:sldMkLst>
        <pc:spChg chg="mod">
          <ac:chgData name="Pešová Michaela" userId="S::1770@fnbrno.cz::ed81fb3f-6043-4d42-bdb6-53f11b6befb6" providerId="AD" clId="Web-{45A2EB75-8ABB-4834-848C-F99142CEA8F9}" dt="2022-09-18T17:58:19.676" v="1" actId="20577"/>
          <ac:spMkLst>
            <pc:docMk/>
            <pc:sldMk cId="3731668930" sldId="256"/>
            <ac:spMk id="8" creationId="{201DABE3-2955-402A-82F2-E39FFE2C2DEE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1E90A0-AC6F-4FBC-B472-A57069A43D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0203C57-EF50-4BBB-BFC3-DC6C0A3F80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467F6B-50A9-43A9-9E73-01F7D43CD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36542-203E-40AB-AF2E-341811F897DD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ED71AF-071A-43DF-8D10-4BFB33C369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FD012C-ADD1-4F7F-9AD2-D59B537CF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B973D-1879-4657-87C5-660E9EC8ABA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8892489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3D3B92-D8C4-46CE-B272-D14FB9D24C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8BCAA4-5F81-420C-90B3-9C0A3E09C5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C082DE-A619-4A9A-835D-AEDB91D2D1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36542-203E-40AB-AF2E-341811F897DD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C16543-5893-4076-9085-FF25CDA04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AF80EB-8630-4067-8919-8A2EC2C530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B973D-1879-4657-87C5-660E9EC8ABA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487304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800143-3341-45C6-B919-A6276EEE2B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6D7DB9-6E8F-4341-AC58-010356A126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681D99-6447-4DDD-AF91-798160774E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36542-203E-40AB-AF2E-341811F897DD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41314C-D083-4836-92C2-719C50BAD4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5BB4C7-2E2D-47B3-B53B-26C80CF764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B973D-1879-4657-87C5-660E9EC8ABA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6047328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957F6E-9511-4B9B-AB29-E1CD4CFBBB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7B0DAE-2425-4ABC-B497-36AEB8E63C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EF89B4-D26E-4779-8AAD-17BC33C992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36542-203E-40AB-AF2E-341811F897DD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2AABCA-F316-414F-94AA-C66AEAD2A3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F70C5F-DF4B-4F55-A60C-ABD602C6BA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B973D-1879-4657-87C5-660E9EC8ABA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083321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96D5DE-B0AF-4069-BF38-CE87DA459D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7D22DA-7F3A-4770-A624-8876491012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44EE11-7622-445D-8DC2-4D99CBEC1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36542-203E-40AB-AF2E-341811F897DD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BE65F2-F622-4280-B904-8CFDE721B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8AB2A1-F519-44E4-A030-C30BBA6B7A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B973D-1879-4657-87C5-660E9EC8ABA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634223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E593A2-3846-4785-9A51-ECC871261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403696-0341-4E84-9256-3D135D6B3B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E05F04-D543-4474-93A8-78271AD6EC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D2E19E-5C0C-4616-8A95-67A8C1B4C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36542-203E-40AB-AF2E-341811F897DD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443B5F-7EEE-4D50-8712-57E5FA2905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13AE1F-E5FC-4C97-9A07-32DD7F8D0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B973D-1879-4657-87C5-660E9EC8ABA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081719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41DA4B-66E6-4762-B926-E9A09DF155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63DC5F-28BC-45F0-BB8C-4EDA88D40D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E8B335C-8658-468D-8480-724890F1F7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968F048-6536-4335-AD07-254376F9F7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35315D-FAF3-47C7-8A8C-FFCE38C109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D152837-042F-49DA-A290-F6D961933B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36542-203E-40AB-AF2E-341811F897DD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598018C-6FAB-4C1E-88C8-E7864C5013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7950BEC-9E9F-4563-B64F-38BDB08872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B973D-1879-4657-87C5-660E9EC8ABA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1897952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155E55-E3C6-4F92-A8E1-AFE42CEA7D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F07DD0B-89CB-488C-823D-1A73C37AA8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36542-203E-40AB-AF2E-341811F897DD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7F4BD5E-CD61-4838-A294-AF4FC44F0F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B13EED2-0644-4AAE-ACB2-5EBAE279B0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B973D-1879-4657-87C5-660E9EC8ABA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824369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69C243-1CC5-4B83-B1FC-A9166D497F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36542-203E-40AB-AF2E-341811F897DD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D7280A4-A1F5-436D-9943-65111DD40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C3F2DA-5018-4507-9197-22EF3441F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B973D-1879-4657-87C5-660E9EC8ABA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441554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2E8445-9179-44BF-B4BE-5B0B6F168B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315131-D213-4016-BB0D-AF4AA76AEF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1AFD1D-3E74-4D6E-B113-E9467D2D30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15D033-B07E-4807-8687-79B0AFFBB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36542-203E-40AB-AF2E-341811F897DD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618AA8-123D-4EFF-AA6E-BB0BF63DC7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B907CC-FF05-4C78-B13B-5E4BFCE775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B973D-1879-4657-87C5-660E9EC8ABA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382167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2DAC76-34E7-47B4-8671-A5ADD9CD83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008198A-53AC-480B-A483-0C78CFEF25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2DE542-2B51-483A-8806-43E32D18AD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ABC4B4-540E-4D98-8636-B780B74E5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136542-203E-40AB-AF2E-341811F897DD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CD09E4-6D2B-4494-B98C-1A9CFA0FB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9ED344-7C68-460E-BAD6-DA715A06C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B973D-1879-4657-87C5-660E9EC8ABA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25959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FE9F3B7-4A40-4EE4-999D-09E022359B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7A1DBA-643C-4EB0-94B0-3ACEE56B89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3AB5B1-7BA2-40FF-9788-F97FD4E9E0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136542-203E-40AB-AF2E-341811F897DD}" type="datetimeFigureOut">
              <a:rPr lang="de-AT" smtClean="0"/>
              <a:t>19.09.2022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34C08A-34F5-4094-80A3-529E7B9F7D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6FB83F-5460-4559-A0E3-926D7CEE84D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7B973D-1879-4657-87C5-660E9EC8ABA0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788042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01DABE3-2955-402A-82F2-E39FFE2C2DEE}"/>
              </a:ext>
            </a:extLst>
          </p:cNvPr>
          <p:cNvSpPr txBox="1"/>
          <p:nvPr/>
        </p:nvSpPr>
        <p:spPr>
          <a:xfrm flipH="1">
            <a:off x="160019" y="4438650"/>
            <a:ext cx="11851006" cy="175432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b="1" dirty="0"/>
              <a:t>Supplementary Figure S7. H2AX phosphorylation. </a:t>
            </a:r>
            <a:r>
              <a:rPr lang="en-US" dirty="0"/>
              <a:t>Representative samples from profile I (N = 4) and profile II (N = 8) were cultured for 30 min (left panel) or 24 h (right panel) </a:t>
            </a:r>
            <a:r>
              <a:rPr lang="en-US" i="1" dirty="0"/>
              <a:t>in vitro </a:t>
            </a:r>
            <a:r>
              <a:rPr lang="en-US" dirty="0"/>
              <a:t>with or without doxorubicin. Afterwards, cells were collected, fixed, permeabilized, stained for H2AX (Ser139), and measured by flow cytometry. Cells with biallelic defects in </a:t>
            </a:r>
            <a:r>
              <a:rPr lang="en-US" i="1" dirty="0"/>
              <a:t>ATM</a:t>
            </a:r>
            <a:r>
              <a:rPr lang="en-US" dirty="0"/>
              <a:t> are depicted with filled symbols. Bars represent the mean values. No significant differences were found between profile I and II samples (Mann-Whitney test for profile comparisons, </a:t>
            </a:r>
            <a:r>
              <a:rPr lang="de-AT" b="0" i="0" dirty="0" err="1">
                <a:solidFill>
                  <a:srgbClr val="242424"/>
                </a:solidFill>
                <a:effectLst/>
                <a:latin typeface="Calibri"/>
                <a:cs typeface="Calibri"/>
              </a:rPr>
              <a:t>Wilcoxon</a:t>
            </a:r>
            <a:r>
              <a:rPr lang="de-AT" b="0" i="0" dirty="0">
                <a:solidFill>
                  <a:srgbClr val="242424"/>
                </a:solidFill>
                <a:effectLst/>
                <a:latin typeface="Calibri"/>
                <a:cs typeface="Calibri"/>
              </a:rPr>
              <a:t> </a:t>
            </a:r>
            <a:r>
              <a:rPr lang="de-AT" b="0" i="0" dirty="0" err="1">
                <a:solidFill>
                  <a:srgbClr val="242424"/>
                </a:solidFill>
                <a:effectLst/>
                <a:latin typeface="Calibri"/>
                <a:cs typeface="Calibri"/>
              </a:rPr>
              <a:t>signed</a:t>
            </a:r>
            <a:r>
              <a:rPr lang="de-AT" b="0" i="0" dirty="0">
                <a:solidFill>
                  <a:srgbClr val="242424"/>
                </a:solidFill>
                <a:effectLst/>
                <a:latin typeface="Calibri"/>
                <a:cs typeface="Calibri"/>
              </a:rPr>
              <a:t> rank </a:t>
            </a:r>
            <a:r>
              <a:rPr lang="de-AT" b="0" i="0" dirty="0" err="1">
                <a:solidFill>
                  <a:srgbClr val="242424"/>
                </a:solidFill>
                <a:effectLst/>
                <a:latin typeface="Calibri"/>
                <a:cs typeface="Calibri"/>
              </a:rPr>
              <a:t>test</a:t>
            </a:r>
            <a:r>
              <a:rPr lang="de-AT" b="0" i="0" dirty="0">
                <a:solidFill>
                  <a:srgbClr val="242424"/>
                </a:solidFill>
                <a:effectLst/>
                <a:latin typeface="Calibri"/>
                <a:cs typeface="Calibri"/>
              </a:rPr>
              <a:t> </a:t>
            </a:r>
            <a:r>
              <a:rPr lang="en-US" dirty="0"/>
              <a:t>for paired comparisons between untreated and treated paired samples).</a:t>
            </a:r>
            <a:endParaRPr lang="de-AT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EE68ED5-2450-4C59-8FBE-CF06CA5038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0639" y="1216025"/>
            <a:ext cx="4152900" cy="259715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7878241-F87D-41BC-9EE0-396475E8AC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10805" y="1216025"/>
            <a:ext cx="4152900" cy="2597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1668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ronika Mancikova</dc:creator>
  <cp:lastModifiedBy>Veronika Mancikova</cp:lastModifiedBy>
  <cp:revision>9</cp:revision>
  <dcterms:created xsi:type="dcterms:W3CDTF">2022-09-16T14:47:02Z</dcterms:created>
  <dcterms:modified xsi:type="dcterms:W3CDTF">2022-09-19T12:40:38Z</dcterms:modified>
</cp:coreProperties>
</file>